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6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F72C4D63-5AB8-4686-A4FD-D7F2930A7C9C}">
          <p14:sldIdLst>
            <p14:sldId id="276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909" autoAdjust="0"/>
    <p:restoredTop sz="94552" autoAdjust="0"/>
  </p:normalViewPr>
  <p:slideViewPr>
    <p:cSldViewPr snapToGrid="0">
      <p:cViewPr varScale="1">
        <p:scale>
          <a:sx n="108" d="100"/>
          <a:sy n="108" d="100"/>
        </p:scale>
        <p:origin x="2034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23256D-21BC-4272-8A62-44FFD7B2F28D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206A81-E7AA-4295-BE03-6221A7FDB4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0463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111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5293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6694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3512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1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6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674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135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8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850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5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2730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7645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8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2768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8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3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854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7636F829-E864-7465-60CF-0187D71287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0789072"/>
              </p:ext>
            </p:extLst>
          </p:nvPr>
        </p:nvGraphicFramePr>
        <p:xfrm>
          <a:off x="3360274" y="869798"/>
          <a:ext cx="2015728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687693" imgH="3962415" progId="Prism10.Document">
                  <p:embed/>
                </p:oleObj>
              </mc:Choice>
              <mc:Fallback>
                <p:oleObj name="Prism 10" r:id="rId2" imgW="2687693" imgH="396241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360274" y="869798"/>
                        <a:ext cx="2015728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D8C6FFD8-8111-D06F-30B2-68B1C1616C52}"/>
              </a:ext>
            </a:extLst>
          </p:cNvPr>
          <p:cNvSpPr txBox="1"/>
          <p:nvPr/>
        </p:nvSpPr>
        <p:spPr>
          <a:xfrm>
            <a:off x="3286125" y="4003305"/>
            <a:ext cx="2664619" cy="12389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600"/>
              </a:spcBef>
              <a:spcAft>
                <a:spcPts val="300"/>
              </a:spcAft>
              <a:buNone/>
            </a:pPr>
            <a:r>
              <a:rPr lang="en-US" sz="10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1000" b="1" kern="10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1</a:t>
            </a:r>
            <a:r>
              <a:rPr lang="en-US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: Depot differences in mean lipid droplet area (μm2). Same data as in Figure 3B, but here comparing VAT vs. SAT for each gel density. Each data-point represents mean lipid droplet area per cell for an individual cell. ns P&gt;0.05, ***P&lt;0.001; ****P&lt;0.0001 between indicated arms. </a:t>
            </a:r>
            <a:endParaRPr lang="en-US" sz="10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29021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03</TotalTime>
  <Words>65</Words>
  <Application>Microsoft Office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'Rourke, Robert</dc:creator>
  <cp:lastModifiedBy>MDPI</cp:lastModifiedBy>
  <cp:revision>120</cp:revision>
  <dcterms:created xsi:type="dcterms:W3CDTF">2024-08-06T14:41:35Z</dcterms:created>
  <dcterms:modified xsi:type="dcterms:W3CDTF">2025-11-09T06:44:31Z</dcterms:modified>
</cp:coreProperties>
</file>